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4"/>
  </p:normalViewPr>
  <p:slideViewPr>
    <p:cSldViewPr snapToGrid="0">
      <p:cViewPr varScale="1">
        <p:scale>
          <a:sx n="104" d="100"/>
          <a:sy n="104" d="100"/>
        </p:scale>
        <p:origin x="232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BA4A67-8111-86C0-6797-DE141F00B1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A7F0AE8-FF1F-7ADD-655A-25680169EB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8A1FC42-D879-C223-B1AD-E7EF000B0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1418800-CB01-E429-E737-FE379A2CA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7A036D3-0AEB-AE0A-FE81-BB7298A82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11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33E527D-2661-3556-0594-F05F5F8675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33833EF-881B-0525-A39C-C6B840F7A3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18976B3-EB46-60A8-3470-1CDE7C5D2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6068C17-1F5A-3B05-387C-430D42333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95E319A-E713-972F-C601-381A6A46B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9165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59EA6E9-6569-811B-4B46-B6755945CD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B2707E7-2F67-7BF8-0FC6-A65F048F98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705CDC0-44DC-1E8D-44F9-B5ACC9E9C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9738E9A-B75F-CC59-37AA-EA1DEFC1E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F0A90AE-7F6B-F493-E327-92DA91D43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2272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4928EB-5893-554F-E971-D7554E9070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6A633A7-1CD9-0492-BA4A-821DFA8AFF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8589D9-7FF3-11FF-A95B-A0FCDFCAC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6EFABB2-4DC9-4EBB-DA58-26A13DAB7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1AE289-8AC4-5223-A257-FF6D39D41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6676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9257499-A693-F2F8-CD6E-0C79110B9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F58DAA2-79A8-57E4-9224-683583CFD4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9F9BE3-B19F-A373-C6C2-F18D01FE7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B9A0729-D672-3C7C-C89E-16599B198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1C5F308-86F4-5344-FD74-E4272B0AE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4790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E58FF1-D72D-1993-2434-6D2F8618D9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9053A6B-446A-8A70-FF46-EB15B972F7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D1012A5-0022-4FA0-2940-E6AA37054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1675CC8-7EC2-5F43-D8E5-25D98D74D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0087A8C-BE6F-26C7-CA45-63691674F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48AD6EA-CB1C-8B0A-18EC-21342CCBB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8529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C5997F3-0722-57E9-A22A-9EBC0DDF54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572A3DB-45C7-F5BD-624C-823AF80A1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C38C84C-0CBD-A1C4-FCF7-6C7BC2FC84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543D920-E408-A46E-7800-61EF5A6C69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4469DAE-6F94-08AF-A418-D3D99FAEEB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F6FCBE5-B507-42B9-3A3E-EA132D467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E9DA2AA-6E05-8311-C2B2-B52962B7A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3B7601FF-729E-9F8B-3D61-83F2EF746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7681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F0F6C1-F7F4-66DA-AC13-3BF742C9B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74CDF95-C05A-C62F-F5E8-5D0E547E4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B257EEA-C2AD-8F7E-0D1E-FD37C7666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D4DCAC8-CC24-519E-011A-94F3C22ED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172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3E44B4F-1335-B1DC-0D01-3BDD4F245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01F100A-3C79-FB16-EF22-22F0BD1B3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21AA4CE-2E64-E9FD-3A65-F9140CD34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9909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84C8C4-4A81-9C8D-B063-3982163E5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1C551AC-DCBD-93D6-21CC-F7F99F0199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6AD3650-CCBE-1102-7A51-E67FD9B8ED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96ECAD8-A0C6-2277-79AA-913CD91E6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E26B329-7A05-1D78-FE2C-39A290577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36B5671-A77F-2BDB-0630-52EBEC339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1434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9775F7-7970-9C15-6099-B09BD4109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4B21629-ECC8-8D66-5F09-C79F8C2EF1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0BA7987-46A8-1BA5-C59E-3AC94020B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555943C-84E1-CE06-748E-341793B6B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6C5D0F7-0191-29D4-991E-FE0DEBC51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F13FC13-5F9A-E811-5D1A-124274BF9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0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3A8D661-C084-0E98-7775-1B995861C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4D7C763-D191-3145-9698-4C3A9581CF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9078C29-F7CC-6E46-0226-1477F2ECC6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1491F-F3B3-DD4D-BE24-05A956BE0958}" type="datetimeFigureOut">
              <a:rPr lang="de-DE" smtClean="0"/>
              <a:t>23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9556D11-9584-C879-016F-A1F45E376B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84D36A7-DA31-5335-9F65-57B137E1A5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6D754-D098-1D4B-B10D-D26AC9653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636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44AE39BF-74E4-1F73-B5DF-6508232BC3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737" y="1572365"/>
            <a:ext cx="3373684" cy="3600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195DB5CC-1FDA-A644-6000-515DC0DAD7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6267" y="1572365"/>
            <a:ext cx="3585938" cy="360000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6D0AE3E7-B018-6C70-E5E8-79086AD70B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13630" y="1572365"/>
            <a:ext cx="3670000" cy="3600000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6575AB71-A14A-6AFB-3A27-4A5A0ADED4C3}"/>
              </a:ext>
            </a:extLst>
          </p:cNvPr>
          <p:cNvSpPr txBox="1"/>
          <p:nvPr/>
        </p:nvSpPr>
        <p:spPr>
          <a:xfrm>
            <a:off x="617839" y="157236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454A4EA1-D0D0-7277-3B52-CEB342CF7DD3}"/>
              </a:ext>
            </a:extLst>
          </p:cNvPr>
          <p:cNvSpPr txBox="1"/>
          <p:nvPr/>
        </p:nvSpPr>
        <p:spPr>
          <a:xfrm>
            <a:off x="4230613" y="157236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D0743B3E-A730-BC24-BA4C-AF951846E39E}"/>
              </a:ext>
            </a:extLst>
          </p:cNvPr>
          <p:cNvSpPr txBox="1"/>
          <p:nvPr/>
        </p:nvSpPr>
        <p:spPr>
          <a:xfrm>
            <a:off x="8176548" y="1572365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E02040C1-2E26-D7AA-25CA-320D815EF523}"/>
              </a:ext>
            </a:extLst>
          </p:cNvPr>
          <p:cNvSpPr txBox="1"/>
          <p:nvPr/>
        </p:nvSpPr>
        <p:spPr>
          <a:xfrm>
            <a:off x="426020" y="172995"/>
            <a:ext cx="113064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Examples of semiquantitative scoring of PD-L1 in immune cells. A) PD-L1 negative: no staining in any immune cells, B) PD-L1 positivity in few immune cells, C) PD-L1 positivity in many immune cells. </a:t>
            </a:r>
          </a:p>
        </p:txBody>
      </p:sp>
    </p:spTree>
    <p:extLst>
      <p:ext uri="{BB962C8B-B14F-4D97-AF65-F5344CB8AC3E}">
        <p14:creationId xmlns:p14="http://schemas.microsoft.com/office/powerpoint/2010/main" val="2911789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Macintosh PowerPoint</Application>
  <PresentationFormat>Breitbild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2</cp:revision>
  <dcterms:created xsi:type="dcterms:W3CDTF">2024-01-23T10:53:05Z</dcterms:created>
  <dcterms:modified xsi:type="dcterms:W3CDTF">2024-01-23T11:07:18Z</dcterms:modified>
</cp:coreProperties>
</file>